
<file path=[Content_Types].xml><?xml version="1.0" encoding="utf-8"?>
<Types xmlns="http://schemas.openxmlformats.org/package/2006/content-types">
  <Default Extension="png" ContentType="image/png"/>
  <Default Extension="svg" ContentType="image/svg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73985"/>
    <a:srgbClr val="7B0000"/>
    <a:srgbClr val="020202"/>
    <a:srgbClr val="B0B0B0"/>
    <a:srgbClr val="000000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8825612-CE25-4084-AF2B-AE2CB0E3834E}" v="1" dt="2018-08-22T08:22:43.48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03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7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imo Mühlhaus" userId="1b6b3aba618dadac" providerId="LiveId" clId="{38825612-CE25-4084-AF2B-AE2CB0E3834E}"/>
    <pc:docChg chg="modSld">
      <pc:chgData name="Timo Mühlhaus" userId="1b6b3aba618dadac" providerId="LiveId" clId="{38825612-CE25-4084-AF2B-AE2CB0E3834E}" dt="2018-08-22T08:22:43.485" v="0" actId="20577"/>
      <pc:docMkLst>
        <pc:docMk/>
      </pc:docMkLst>
      <pc:sldChg chg="modSp">
        <pc:chgData name="Timo Mühlhaus" userId="1b6b3aba618dadac" providerId="LiveId" clId="{38825612-CE25-4084-AF2B-AE2CB0E3834E}" dt="2018-08-22T08:22:43.485" v="0" actId="20577"/>
        <pc:sldMkLst>
          <pc:docMk/>
          <pc:sldMk cId="2550446981" sldId="257"/>
        </pc:sldMkLst>
        <pc:spChg chg="mod">
          <ac:chgData name="Timo Mühlhaus" userId="1b6b3aba618dadac" providerId="LiveId" clId="{38825612-CE25-4084-AF2B-AE2CB0E3834E}" dt="2018-08-22T08:22:43.485" v="0" actId="20577"/>
          <ac:spMkLst>
            <pc:docMk/>
            <pc:sldMk cId="2550446981" sldId="257"/>
            <ac:spMk id="25" creationId="{8CC5F223-9599-41E7-993E-137FD4E7DF8C}"/>
          </ac:spMkLst>
        </pc:spChg>
      </pc:sldChg>
    </pc:docChg>
  </pc:docChgLst>
  <pc:docChgLst>
    <pc:chgData name="Timo Mühlhaus" userId="1b6b3aba618dadac" providerId="LiveId" clId="{8E1486AC-A3F1-4ED8-B35C-8CA15D780966}"/>
  </pc:docChgLst>
  <pc:docChgLst>
    <pc:chgData name="Timo Mühlhaus" userId="1b6b3aba618dadac" providerId="LiveId" clId="{DCCCAD8A-BE7C-40E7-B835-1AF8D14CB392}"/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E3BC2-098B-4F41-B677-34B6E4578E18}" type="datetimeFigureOut">
              <a:rPr lang="LID4096" smtClean="0"/>
              <a:t>08/22/2018</a:t>
            </a:fld>
            <a:endParaRPr lang="LID4096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D0A60-5821-4655-9C88-CDD023597AF3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6816273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E3BC2-098B-4F41-B677-34B6E4578E18}" type="datetimeFigureOut">
              <a:rPr lang="LID4096" smtClean="0"/>
              <a:t>08/22/2018</a:t>
            </a:fld>
            <a:endParaRPr lang="LID4096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D0A60-5821-4655-9C88-CDD023597AF3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14295483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E3BC2-098B-4F41-B677-34B6E4578E18}" type="datetimeFigureOut">
              <a:rPr lang="LID4096" smtClean="0"/>
              <a:t>08/22/2018</a:t>
            </a:fld>
            <a:endParaRPr lang="LID4096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D0A60-5821-4655-9C88-CDD023597AF3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26615281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E3BC2-098B-4F41-B677-34B6E4578E18}" type="datetimeFigureOut">
              <a:rPr lang="LID4096" smtClean="0"/>
              <a:t>08/22/2018</a:t>
            </a:fld>
            <a:endParaRPr lang="LID4096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D0A60-5821-4655-9C88-CDD023597AF3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32159253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E3BC2-098B-4F41-B677-34B6E4578E18}" type="datetimeFigureOut">
              <a:rPr lang="LID4096" smtClean="0"/>
              <a:t>08/22/2018</a:t>
            </a:fld>
            <a:endParaRPr lang="LID4096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D0A60-5821-4655-9C88-CDD023597AF3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29520583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E3BC2-098B-4F41-B677-34B6E4578E18}" type="datetimeFigureOut">
              <a:rPr lang="LID4096" smtClean="0"/>
              <a:t>08/22/2018</a:t>
            </a:fld>
            <a:endParaRPr lang="LID4096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D0A60-5821-4655-9C88-CDD023597AF3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39434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E3BC2-098B-4F41-B677-34B6E4578E18}" type="datetimeFigureOut">
              <a:rPr lang="LID4096" smtClean="0"/>
              <a:t>08/22/2018</a:t>
            </a:fld>
            <a:endParaRPr lang="LID4096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D0A60-5821-4655-9C88-CDD023597AF3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21698643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E3BC2-098B-4F41-B677-34B6E4578E18}" type="datetimeFigureOut">
              <a:rPr lang="LID4096" smtClean="0"/>
              <a:t>08/22/2018</a:t>
            </a:fld>
            <a:endParaRPr lang="LID4096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D0A60-5821-4655-9C88-CDD023597AF3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17709047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E3BC2-098B-4F41-B677-34B6E4578E18}" type="datetimeFigureOut">
              <a:rPr lang="LID4096" smtClean="0"/>
              <a:t>08/22/2018</a:t>
            </a:fld>
            <a:endParaRPr lang="LID4096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D0A60-5821-4655-9C88-CDD023597AF3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23045191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E3BC2-098B-4F41-B677-34B6E4578E18}" type="datetimeFigureOut">
              <a:rPr lang="LID4096" smtClean="0"/>
              <a:t>08/22/2018</a:t>
            </a:fld>
            <a:endParaRPr lang="LID4096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D0A60-5821-4655-9C88-CDD023597AF3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8138177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E3BC2-098B-4F41-B677-34B6E4578E18}" type="datetimeFigureOut">
              <a:rPr lang="LID4096" smtClean="0"/>
              <a:t>08/22/2018</a:t>
            </a:fld>
            <a:endParaRPr lang="LID4096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D0A60-5821-4655-9C88-CDD023597AF3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24943612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BE3BC2-098B-4F41-B677-34B6E4578E18}" type="datetimeFigureOut">
              <a:rPr lang="LID4096" smtClean="0"/>
              <a:t>08/22/2018</a:t>
            </a:fld>
            <a:endParaRPr lang="LID4096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LID4096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CD0A60-5821-4655-9C88-CDD023597AF3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26772925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svg"/><Relationship Id="rId18" Type="http://schemas.openxmlformats.org/officeDocument/2006/relationships/image" Target="../media/image17.png"/><Relationship Id="rId3" Type="http://schemas.openxmlformats.org/officeDocument/2006/relationships/image" Target="../media/image2.svg"/><Relationship Id="rId21" Type="http://schemas.openxmlformats.org/officeDocument/2006/relationships/image" Target="../media/image20.svg"/><Relationship Id="rId7" Type="http://schemas.openxmlformats.org/officeDocument/2006/relationships/image" Target="../media/image6.svg"/><Relationship Id="rId12" Type="http://schemas.openxmlformats.org/officeDocument/2006/relationships/image" Target="../media/image11.png"/><Relationship Id="rId17" Type="http://schemas.openxmlformats.org/officeDocument/2006/relationships/image" Target="../media/image16.sv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svg"/><Relationship Id="rId5" Type="http://schemas.openxmlformats.org/officeDocument/2006/relationships/image" Target="../media/image4.svg"/><Relationship Id="rId15" Type="http://schemas.openxmlformats.org/officeDocument/2006/relationships/image" Target="../media/image14.svg"/><Relationship Id="rId10" Type="http://schemas.openxmlformats.org/officeDocument/2006/relationships/image" Target="../media/image9.png"/><Relationship Id="rId19" Type="http://schemas.openxmlformats.org/officeDocument/2006/relationships/image" Target="../media/image18.svg"/><Relationship Id="rId4" Type="http://schemas.openxmlformats.org/officeDocument/2006/relationships/image" Target="../media/image3.png"/><Relationship Id="rId9" Type="http://schemas.openxmlformats.org/officeDocument/2006/relationships/image" Target="../media/image8.sv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>
            <a:extLst>
              <a:ext uri="{FF2B5EF4-FFF2-40B4-BE49-F238E27FC236}">
                <a16:creationId xmlns:a16="http://schemas.microsoft.com/office/drawing/2014/main" id="{8CC5F223-9599-41E7-993E-137FD4E7DF8C}"/>
              </a:ext>
            </a:extLst>
          </p:cNvPr>
          <p:cNvSpPr txBox="1"/>
          <p:nvPr/>
        </p:nvSpPr>
        <p:spPr>
          <a:xfrm>
            <a:off x="473987" y="3110028"/>
            <a:ext cx="502177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Figure 3. Plots of ratios of </a:t>
            </a:r>
            <a:r>
              <a:rPr lang="de-DE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N Q-peptides to </a:t>
            </a:r>
            <a:r>
              <a:rPr lang="de-DE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N native peptides versus the amount of PS-Qprot added.</a:t>
            </a:r>
          </a:p>
          <a:p>
            <a:pPr algn="just"/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Each data point represents the mean of 4 biological replicates (values and SD are compiled in Supplemental Dataset 1).</a:t>
            </a:r>
          </a:p>
        </p:txBody>
      </p:sp>
      <p:pic>
        <p:nvPicPr>
          <p:cNvPr id="2" name="Graphic 1">
            <a:extLst>
              <a:ext uri="{FF2B5EF4-FFF2-40B4-BE49-F238E27FC236}">
                <a16:creationId xmlns:a16="http://schemas.microsoft.com/office/drawing/2014/main" id="{7D3D2AC9-EED3-4300-9172-58AF77E3EA2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rcRect l="6857" t="15641" b="9660"/>
          <a:stretch/>
        </p:blipFill>
        <p:spPr>
          <a:xfrm>
            <a:off x="5168992" y="1877525"/>
            <a:ext cx="1453320" cy="999038"/>
          </a:xfrm>
          <a:prstGeom prst="rect">
            <a:avLst/>
          </a:prstGeom>
        </p:spPr>
      </p:pic>
      <p:pic>
        <p:nvPicPr>
          <p:cNvPr id="4" name="Graphic 3">
            <a:extLst>
              <a:ext uri="{FF2B5EF4-FFF2-40B4-BE49-F238E27FC236}">
                <a16:creationId xmlns:a16="http://schemas.microsoft.com/office/drawing/2014/main" id="{E7DDD350-A5F8-4BC9-B3F5-1CB8AD2088F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rcRect l="6857" t="15640"/>
          <a:stretch/>
        </p:blipFill>
        <p:spPr>
          <a:xfrm>
            <a:off x="2884257" y="632291"/>
            <a:ext cx="1453320" cy="1128239"/>
          </a:xfrm>
          <a:prstGeom prst="rect">
            <a:avLst/>
          </a:prstGeom>
        </p:spPr>
      </p:pic>
      <p:pic>
        <p:nvPicPr>
          <p:cNvPr id="5" name="Graphic 4">
            <a:extLst>
              <a:ext uri="{FF2B5EF4-FFF2-40B4-BE49-F238E27FC236}">
                <a16:creationId xmlns:a16="http://schemas.microsoft.com/office/drawing/2014/main" id="{2A261DF9-B5E0-4F18-9BC0-421ED5AB47DE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7"/>
              </a:ext>
            </a:extLst>
          </a:blip>
          <a:srcRect l="7401" t="15552"/>
          <a:stretch/>
        </p:blipFill>
        <p:spPr>
          <a:xfrm>
            <a:off x="2893924" y="1879435"/>
            <a:ext cx="1444825" cy="1129423"/>
          </a:xfrm>
          <a:prstGeom prst="rect">
            <a:avLst/>
          </a:prstGeom>
        </p:spPr>
      </p:pic>
      <p:pic>
        <p:nvPicPr>
          <p:cNvPr id="6" name="Graphic 5">
            <a:extLst>
              <a:ext uri="{FF2B5EF4-FFF2-40B4-BE49-F238E27FC236}">
                <a16:creationId xmlns:a16="http://schemas.microsoft.com/office/drawing/2014/main" id="{CA90B376-7887-4BC0-9371-EC0CD86B6436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9"/>
              </a:ext>
            </a:extLst>
          </a:blip>
          <a:srcRect l="7346" t="15552" b="10256"/>
          <a:stretch/>
        </p:blipFill>
        <p:spPr>
          <a:xfrm>
            <a:off x="1756277" y="1876340"/>
            <a:ext cx="1445705" cy="992258"/>
          </a:xfrm>
          <a:prstGeom prst="rect">
            <a:avLst/>
          </a:prstGeom>
        </p:spPr>
      </p:pic>
      <p:pic>
        <p:nvPicPr>
          <p:cNvPr id="7" name="Graphic 6">
            <a:extLst>
              <a:ext uri="{FF2B5EF4-FFF2-40B4-BE49-F238E27FC236}">
                <a16:creationId xmlns:a16="http://schemas.microsoft.com/office/drawing/2014/main" id="{F882E3A8-C83E-477D-AC5D-0788A3BC9158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1"/>
              </a:ext>
            </a:extLst>
          </a:blip>
          <a:srcRect l="7344" t="15045" b="10255"/>
          <a:stretch/>
        </p:blipFill>
        <p:spPr>
          <a:xfrm>
            <a:off x="4056190" y="1868973"/>
            <a:ext cx="1445706" cy="999037"/>
          </a:xfrm>
          <a:prstGeom prst="rect">
            <a:avLst/>
          </a:prstGeom>
        </p:spPr>
      </p:pic>
      <p:pic>
        <p:nvPicPr>
          <p:cNvPr id="10" name="Graphic 9">
            <a:extLst>
              <a:ext uri="{FF2B5EF4-FFF2-40B4-BE49-F238E27FC236}">
                <a16:creationId xmlns:a16="http://schemas.microsoft.com/office/drawing/2014/main" id="{8289DA39-5AA9-43FD-9897-81111EA0D64C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3"/>
              </a:ext>
            </a:extLst>
          </a:blip>
          <a:srcRect l="6857" t="15641" b="9660"/>
          <a:stretch/>
        </p:blipFill>
        <p:spPr>
          <a:xfrm>
            <a:off x="1746964" y="624191"/>
            <a:ext cx="1453320" cy="999037"/>
          </a:xfrm>
          <a:prstGeom prst="rect">
            <a:avLst/>
          </a:prstGeom>
        </p:spPr>
      </p:pic>
      <p:pic>
        <p:nvPicPr>
          <p:cNvPr id="12" name="Graphic 11">
            <a:extLst>
              <a:ext uri="{FF2B5EF4-FFF2-40B4-BE49-F238E27FC236}">
                <a16:creationId xmlns:a16="http://schemas.microsoft.com/office/drawing/2014/main" id="{59046F34-15F9-434A-B9A5-F2DC020BD704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5"/>
              </a:ext>
            </a:extLst>
          </a:blip>
          <a:srcRect l="7457" t="11018" b="10168"/>
          <a:stretch/>
        </p:blipFill>
        <p:spPr>
          <a:xfrm>
            <a:off x="638875" y="565470"/>
            <a:ext cx="1443958" cy="1054075"/>
          </a:xfrm>
          <a:prstGeom prst="rect">
            <a:avLst/>
          </a:prstGeom>
        </p:spPr>
      </p:pic>
      <p:pic>
        <p:nvPicPr>
          <p:cNvPr id="14" name="Graphic 13">
            <a:extLst>
              <a:ext uri="{FF2B5EF4-FFF2-40B4-BE49-F238E27FC236}">
                <a16:creationId xmlns:a16="http://schemas.microsoft.com/office/drawing/2014/main" id="{B9A11F24-7ECA-4487-9186-FAABC9DFBE94}"/>
              </a:ext>
            </a:extLst>
          </p:cNvPr>
          <p:cNvPicPr>
            <a:picLocks noChangeAspect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7"/>
              </a:ext>
            </a:extLst>
          </a:blip>
          <a:srcRect l="6857" t="15641" b="9660"/>
          <a:stretch/>
        </p:blipFill>
        <p:spPr>
          <a:xfrm>
            <a:off x="4045274" y="624192"/>
            <a:ext cx="1453320" cy="999037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19FEBC91-38E4-4635-B374-57C1F04C067F}"/>
              </a:ext>
            </a:extLst>
          </p:cNvPr>
          <p:cNvSpPr txBox="1"/>
          <p:nvPr/>
        </p:nvSpPr>
        <p:spPr>
          <a:xfrm>
            <a:off x="1111926" y="503371"/>
            <a:ext cx="381532" cy="2096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00" dirty="0">
                <a:latin typeface="Arial" panose="020B0604020202020204" pitchFamily="34" charset="0"/>
                <a:cs typeface="Arial" panose="020B0604020202020204" pitchFamily="34" charset="0"/>
              </a:rPr>
              <a:t>rbcL</a:t>
            </a:r>
            <a:endParaRPr lang="LID4096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09C462B-AB9E-4BE4-B2D0-5C05BAF2CAD8}"/>
              </a:ext>
            </a:extLst>
          </p:cNvPr>
          <p:cNvSpPr txBox="1"/>
          <p:nvPr/>
        </p:nvSpPr>
        <p:spPr>
          <a:xfrm>
            <a:off x="2236216" y="503371"/>
            <a:ext cx="451008" cy="2096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00" dirty="0">
                <a:latin typeface="Arial" panose="020B0604020202020204" pitchFamily="34" charset="0"/>
                <a:cs typeface="Arial" panose="020B0604020202020204" pitchFamily="34" charset="0"/>
              </a:rPr>
              <a:t>RBCS</a:t>
            </a:r>
            <a:endParaRPr lang="LID4096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CEBCD44-48AE-4878-8A36-E6ABC70CD9E9}"/>
              </a:ext>
            </a:extLst>
          </p:cNvPr>
          <p:cNvSpPr txBox="1"/>
          <p:nvPr/>
        </p:nvSpPr>
        <p:spPr>
          <a:xfrm>
            <a:off x="3228631" y="503369"/>
            <a:ext cx="730903" cy="2096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00" dirty="0">
                <a:latin typeface="Arial" panose="020B0604020202020204" pitchFamily="34" charset="0"/>
                <a:cs typeface="Arial" panose="020B0604020202020204" pitchFamily="34" charset="0"/>
              </a:rPr>
              <a:t>EPYC1 (LCI5)</a:t>
            </a:r>
            <a:endParaRPr lang="LID4096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CCF324B-AFA8-4C11-9EC1-3FA8DA5DBFFA}"/>
              </a:ext>
            </a:extLst>
          </p:cNvPr>
          <p:cNvSpPr txBox="1"/>
          <p:nvPr/>
        </p:nvSpPr>
        <p:spPr>
          <a:xfrm>
            <a:off x="4501828" y="503368"/>
            <a:ext cx="441084" cy="2096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00" dirty="0">
                <a:latin typeface="Arial" panose="020B0604020202020204" pitchFamily="34" charset="0"/>
                <a:cs typeface="Arial" panose="020B0604020202020204" pitchFamily="34" charset="0"/>
              </a:rPr>
              <a:t>RCA1</a:t>
            </a:r>
            <a:endParaRPr lang="LID4096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9DE60A0-F2E7-456D-BEA8-44C6592140AD}"/>
              </a:ext>
            </a:extLst>
          </p:cNvPr>
          <p:cNvSpPr txBox="1"/>
          <p:nvPr/>
        </p:nvSpPr>
        <p:spPr>
          <a:xfrm>
            <a:off x="5574063" y="503367"/>
            <a:ext cx="584009" cy="2096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00" dirty="0">
                <a:latin typeface="Arial" panose="020B0604020202020204" pitchFamily="34" charset="0"/>
                <a:cs typeface="Arial" panose="020B0604020202020204" pitchFamily="34" charset="0"/>
              </a:rPr>
              <a:t>psbA (D1)</a:t>
            </a:r>
            <a:endParaRPr lang="LID4096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Graphic 19">
            <a:extLst>
              <a:ext uri="{FF2B5EF4-FFF2-40B4-BE49-F238E27FC236}">
                <a16:creationId xmlns:a16="http://schemas.microsoft.com/office/drawing/2014/main" id="{9708A0AD-489A-47E6-9DB8-FE884C603AFE}"/>
              </a:ext>
            </a:extLst>
          </p:cNvPr>
          <p:cNvPicPr>
            <a:picLocks noChangeAspect="1"/>
          </p:cNvPicPr>
          <p:nvPr/>
        </p:nvPicPr>
        <p:blipFill rotWithShape="1">
          <a:blip r:embed="rId18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9"/>
              </a:ext>
            </a:extLst>
          </a:blip>
          <a:srcRect l="6857" t="15133" b="10167"/>
          <a:stretch/>
        </p:blipFill>
        <p:spPr>
          <a:xfrm>
            <a:off x="5170868" y="617407"/>
            <a:ext cx="1453320" cy="999037"/>
          </a:xfrm>
          <a:prstGeom prst="rect">
            <a:avLst/>
          </a:prstGeom>
        </p:spPr>
      </p:pic>
      <p:pic>
        <p:nvPicPr>
          <p:cNvPr id="21" name="Graphic 20">
            <a:extLst>
              <a:ext uri="{FF2B5EF4-FFF2-40B4-BE49-F238E27FC236}">
                <a16:creationId xmlns:a16="http://schemas.microsoft.com/office/drawing/2014/main" id="{91A2522C-D42C-4BF8-A87C-73DCECDB49FC}"/>
              </a:ext>
            </a:extLst>
          </p:cNvPr>
          <p:cNvPicPr>
            <a:picLocks noChangeAspect="1"/>
          </p:cNvPicPr>
          <p:nvPr/>
        </p:nvPicPr>
        <p:blipFill rotWithShape="1">
          <a:blip r:embed="rId20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21"/>
              </a:ext>
            </a:extLst>
          </a:blip>
          <a:srcRect l="7346" t="15552" b="9749"/>
          <a:stretch/>
        </p:blipFill>
        <p:spPr>
          <a:xfrm>
            <a:off x="641412" y="1873249"/>
            <a:ext cx="1445705" cy="999037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7F142AEF-1550-4190-83E8-03AC33903B7B}"/>
              </a:ext>
            </a:extLst>
          </p:cNvPr>
          <p:cNvSpPr txBox="1"/>
          <p:nvPr/>
        </p:nvSpPr>
        <p:spPr>
          <a:xfrm>
            <a:off x="2155333" y="1753606"/>
            <a:ext cx="609814" cy="2096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00" dirty="0">
                <a:latin typeface="Arial" panose="020B0604020202020204" pitchFamily="34" charset="0"/>
                <a:cs typeface="Arial" panose="020B0604020202020204" pitchFamily="34" charset="0"/>
              </a:rPr>
              <a:t>petA (cyt </a:t>
            </a:r>
            <a:r>
              <a:rPr lang="de-DE" sz="500" i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de-DE" sz="5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LID4096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C37D822-B140-4164-B7D0-93D8DE768661}"/>
              </a:ext>
            </a:extLst>
          </p:cNvPr>
          <p:cNvSpPr txBox="1"/>
          <p:nvPr/>
        </p:nvSpPr>
        <p:spPr>
          <a:xfrm>
            <a:off x="1026001" y="1752430"/>
            <a:ext cx="587978" cy="2096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00" dirty="0">
                <a:latin typeface="Arial" panose="020B0604020202020204" pitchFamily="34" charset="0"/>
                <a:cs typeface="Arial" panose="020B0604020202020204" pitchFamily="34" charset="0"/>
              </a:rPr>
              <a:t>psbD (D2)</a:t>
            </a:r>
            <a:endParaRPr lang="LID4096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7A8BE8FE-5C6D-4BE9-B5B9-F4519CDFCD8A}"/>
              </a:ext>
            </a:extLst>
          </p:cNvPr>
          <p:cNvSpPr txBox="1"/>
          <p:nvPr/>
        </p:nvSpPr>
        <p:spPr>
          <a:xfrm>
            <a:off x="3331002" y="1744336"/>
            <a:ext cx="437113" cy="2096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00" dirty="0">
                <a:latin typeface="Arial" panose="020B0604020202020204" pitchFamily="34" charset="0"/>
                <a:cs typeface="Arial" panose="020B0604020202020204" pitchFamily="34" charset="0"/>
              </a:rPr>
              <a:t>PCY1</a:t>
            </a:r>
            <a:endParaRPr lang="LID4096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AD4618B-D467-4770-913B-44B6FB3E5F2F}"/>
              </a:ext>
            </a:extLst>
          </p:cNvPr>
          <p:cNvSpPr txBox="1"/>
          <p:nvPr/>
        </p:nvSpPr>
        <p:spPr>
          <a:xfrm>
            <a:off x="4507759" y="1759212"/>
            <a:ext cx="409323" cy="2096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00" dirty="0">
                <a:latin typeface="Arial" panose="020B0604020202020204" pitchFamily="34" charset="0"/>
                <a:cs typeface="Arial" panose="020B0604020202020204" pitchFamily="34" charset="0"/>
              </a:rPr>
              <a:t>psaB</a:t>
            </a:r>
            <a:endParaRPr lang="LID4096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1BC6E673-B5C5-45C4-9A4B-D55F2DABA4B1}"/>
              </a:ext>
            </a:extLst>
          </p:cNvPr>
          <p:cNvSpPr txBox="1"/>
          <p:nvPr/>
        </p:nvSpPr>
        <p:spPr>
          <a:xfrm>
            <a:off x="5657891" y="1764251"/>
            <a:ext cx="391456" cy="2096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00" dirty="0">
                <a:latin typeface="Arial" panose="020B0604020202020204" pitchFamily="34" charset="0"/>
                <a:cs typeface="Arial" panose="020B0604020202020204" pitchFamily="34" charset="0"/>
              </a:rPr>
              <a:t>atpB</a:t>
            </a:r>
            <a:endParaRPr lang="LID4096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" name="Graphic 29">
            <a:extLst>
              <a:ext uri="{FF2B5EF4-FFF2-40B4-BE49-F238E27FC236}">
                <a16:creationId xmlns:a16="http://schemas.microsoft.com/office/drawing/2014/main" id="{7192BBFC-61A7-43F3-A5ED-932E4A169A2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rcRect l="52558" t="64145" r="22772" b="19048"/>
          <a:stretch/>
        </p:blipFill>
        <p:spPr>
          <a:xfrm>
            <a:off x="5354732" y="1964862"/>
            <a:ext cx="384941" cy="224782"/>
          </a:xfrm>
          <a:prstGeom prst="rect">
            <a:avLst/>
          </a:prstGeom>
        </p:spPr>
      </p:pic>
      <p:sp>
        <p:nvSpPr>
          <p:cNvPr id="31" name="Rectangle 30">
            <a:extLst>
              <a:ext uri="{FF2B5EF4-FFF2-40B4-BE49-F238E27FC236}">
                <a16:creationId xmlns:a16="http://schemas.microsoft.com/office/drawing/2014/main" id="{570670B8-15DA-4AD4-86D8-364106815B7C}"/>
              </a:ext>
            </a:extLst>
          </p:cNvPr>
          <p:cNvSpPr/>
          <p:nvPr/>
        </p:nvSpPr>
        <p:spPr>
          <a:xfrm>
            <a:off x="5866067" y="2509556"/>
            <a:ext cx="424827" cy="2096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LID4096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98BEE7F-D550-4104-98EF-4F17BF576953}"/>
              </a:ext>
            </a:extLst>
          </p:cNvPr>
          <p:cNvSpPr txBox="1"/>
          <p:nvPr/>
        </p:nvSpPr>
        <p:spPr>
          <a:xfrm rot="16200000">
            <a:off x="-18916" y="1520364"/>
            <a:ext cx="1199342" cy="1758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00" baseline="300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r>
              <a:rPr lang="de-DE" sz="500" dirty="0">
                <a:latin typeface="Arial" panose="020B0604020202020204" pitchFamily="34" charset="0"/>
                <a:cs typeface="Arial" panose="020B0604020202020204" pitchFamily="34" charset="0"/>
              </a:rPr>
              <a:t>N Q-peptide / </a:t>
            </a:r>
            <a:r>
              <a:rPr lang="de-DE" sz="500" baseline="300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r>
              <a:rPr lang="de-DE" sz="500" dirty="0">
                <a:latin typeface="Arial" panose="020B0604020202020204" pitchFamily="34" charset="0"/>
                <a:cs typeface="Arial" panose="020B0604020202020204" pitchFamily="34" charset="0"/>
              </a:rPr>
              <a:t>N native peptide </a:t>
            </a:r>
            <a:endParaRPr lang="LID4096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504469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95</TotalTime>
  <Words>71</Words>
  <Application>Microsoft Office PowerPoint</Application>
  <PresentationFormat>A4 Paper (210x297 mm)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Schroda</dc:creator>
  <cp:lastModifiedBy>Timo Mühlhaus</cp:lastModifiedBy>
  <cp:revision>28</cp:revision>
  <dcterms:created xsi:type="dcterms:W3CDTF">2018-04-27T10:11:01Z</dcterms:created>
  <dcterms:modified xsi:type="dcterms:W3CDTF">2018-08-22T08:22:48Z</dcterms:modified>
</cp:coreProperties>
</file>